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28" r:id="rId2"/>
  </p:sldIdLst>
  <p:sldSz cx="6858000" cy="9144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Daniel Kirouac" initials="DK" lastIdx="0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46"/>
    <a:srgbClr val="0000FF"/>
    <a:srgbClr val="FF0066"/>
    <a:srgbClr val="D9D9D9"/>
    <a:srgbClr val="FF0000"/>
    <a:srgbClr val="9BBB59"/>
    <a:srgbClr val="8064A2"/>
    <a:srgbClr val="C0504D"/>
    <a:srgbClr val="000000"/>
    <a:srgbClr val="CC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9012ECD-51FC-41F1-AA8D-1B2483CD663E}" styleName="Light Style 2 - Accent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D7AC3CCA-C797-4891-BE02-D94E43425B78}" styleName="Medium Styl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9290" autoAdjust="0"/>
  </p:normalViewPr>
  <p:slideViewPr>
    <p:cSldViewPr>
      <p:cViewPr>
        <p:scale>
          <a:sx n="140" d="100"/>
          <a:sy n="140" d="100"/>
        </p:scale>
        <p:origin x="-806" y="-5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dkirouac\Documents\Experimental%20Data%20-%20MMTeams\Experimental%20Data%20-%20MM111\Dose%20Response%20Data\Jin\AKT%20x%20MEK%20inhibitor%20profiling\TCGA%20GUI%20OUTPUT_Biomarker%20Validation.xlsx" TargetMode="External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dkirouac\Documents\Experimental%20Data%20-%20MMTeams\Experimental%20Data%20-%20MM111\Dose%20Response%20Data\Jin\AKT%20x%20MEK%20inhibitor%20profiling\TCGA%20GUI%20OUTPUT_Biomarker%20Validation.xlsx" TargetMode="External"/><Relationship Id="rId1" Type="http://schemas.openxmlformats.org/officeDocument/2006/relationships/themeOverride" Target="../theme/themeOverrid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55168482064741897"/>
          <c:y val="5.0925925925925923E-2"/>
          <c:w val="0.42460695538057736"/>
          <c:h val="0.80806794983960317"/>
        </c:manualLayout>
      </c:layout>
      <c:barChart>
        <c:barDir val="bar"/>
        <c:grouping val="clustered"/>
        <c:varyColors val="0"/>
        <c:ser>
          <c:idx val="0"/>
          <c:order val="0"/>
          <c:tx>
            <c:v>EGFR</c:v>
          </c:tx>
          <c:spPr>
            <a:solidFill>
              <a:srgbClr val="C00000"/>
            </a:solidFill>
            <a:ln>
              <a:solidFill>
                <a:sysClr val="windowText" lastClr="000000"/>
              </a:solidFill>
            </a:ln>
          </c:spPr>
          <c:invertIfNegative val="0"/>
          <c:cat>
            <c:strRef>
              <c:f>STATS!$B$29:$B$38</c:f>
              <c:strCache>
                <c:ptCount val="10"/>
                <c:pt idx="0">
                  <c:v>Uterine carcinosarcoma</c:v>
                </c:pt>
                <c:pt idx="1">
                  <c:v>Ovarian serous cystadenocarcinoma</c:v>
                </c:pt>
                <c:pt idx="2">
                  <c:v>Kidney renal papillary cell carcinoma</c:v>
                </c:pt>
                <c:pt idx="3">
                  <c:v>Cervical squamous cell carcinoma</c:v>
                </c:pt>
                <c:pt idx="4">
                  <c:v>Uterine corpus endometrial carcinoma</c:v>
                </c:pt>
                <c:pt idx="5">
                  <c:v>colon &amp; rectum adenocarcinoma</c:v>
                </c:pt>
                <c:pt idx="6">
                  <c:v>Head and Neck squamous cell carcinoma</c:v>
                </c:pt>
                <c:pt idx="7">
                  <c:v>Lung squamous cell carcinoma</c:v>
                </c:pt>
                <c:pt idx="8">
                  <c:v>Urothelial bladder carcinoma</c:v>
                </c:pt>
                <c:pt idx="9">
                  <c:v>Lung adenocarcinoma</c:v>
                </c:pt>
              </c:strCache>
            </c:strRef>
          </c:cat>
          <c:val>
            <c:numRef>
              <c:f>STATS!$F$29:$F$38</c:f>
              <c:numCache>
                <c:formatCode>General</c:formatCode>
                <c:ptCount val="10"/>
                <c:pt idx="0">
                  <c:v>-0.74885336248111911</c:v>
                </c:pt>
                <c:pt idx="1">
                  <c:v>0.44864752177421297</c:v>
                </c:pt>
                <c:pt idx="2">
                  <c:v>0.68376766202080075</c:v>
                </c:pt>
                <c:pt idx="3">
                  <c:v>0.84634110495906889</c:v>
                </c:pt>
                <c:pt idx="4">
                  <c:v>0.97777529850494627</c:v>
                </c:pt>
                <c:pt idx="5">
                  <c:v>1.8754767484845685</c:v>
                </c:pt>
                <c:pt idx="6">
                  <c:v>2.5107903254405528</c:v>
                </c:pt>
                <c:pt idx="7">
                  <c:v>3.7770408745283155</c:v>
                </c:pt>
                <c:pt idx="8">
                  <c:v>3.971351780949909</c:v>
                </c:pt>
                <c:pt idx="9">
                  <c:v>4.1390907755015949</c:v>
                </c:pt>
              </c:numCache>
            </c:numRef>
          </c:val>
        </c:ser>
        <c:ser>
          <c:idx val="1"/>
          <c:order val="1"/>
          <c:tx>
            <c:v>ERBB3</c:v>
          </c:tx>
          <c:spPr>
            <a:solidFill>
              <a:srgbClr val="0070C0"/>
            </a:solidFill>
            <a:ln>
              <a:solidFill>
                <a:sysClr val="windowText" lastClr="000000"/>
              </a:solidFill>
            </a:ln>
          </c:spPr>
          <c:invertIfNegative val="0"/>
          <c:cat>
            <c:strRef>
              <c:f>STATS!$B$29:$B$38</c:f>
              <c:strCache>
                <c:ptCount val="10"/>
                <c:pt idx="0">
                  <c:v>Uterine carcinosarcoma</c:v>
                </c:pt>
                <c:pt idx="1">
                  <c:v>Ovarian serous cystadenocarcinoma</c:v>
                </c:pt>
                <c:pt idx="2">
                  <c:v>Kidney renal papillary cell carcinoma</c:v>
                </c:pt>
                <c:pt idx="3">
                  <c:v>Cervical squamous cell carcinoma</c:v>
                </c:pt>
                <c:pt idx="4">
                  <c:v>Uterine corpus endometrial carcinoma</c:v>
                </c:pt>
                <c:pt idx="5">
                  <c:v>colon &amp; rectum adenocarcinoma</c:v>
                </c:pt>
                <c:pt idx="6">
                  <c:v>Head and Neck squamous cell carcinoma</c:v>
                </c:pt>
                <c:pt idx="7">
                  <c:v>Lung squamous cell carcinoma</c:v>
                </c:pt>
                <c:pt idx="8">
                  <c:v>Urothelial bladder carcinoma</c:v>
                </c:pt>
                <c:pt idx="9">
                  <c:v>Lung adenocarcinoma</c:v>
                </c:pt>
              </c:strCache>
            </c:strRef>
          </c:cat>
          <c:val>
            <c:numRef>
              <c:f>STATS!$J$29:$J$38</c:f>
              <c:numCache>
                <c:formatCode>General</c:formatCode>
                <c:ptCount val="10"/>
                <c:pt idx="0">
                  <c:v>-2.5170991775025087</c:v>
                </c:pt>
                <c:pt idx="1">
                  <c:v>-2.3831652861121171</c:v>
                </c:pt>
                <c:pt idx="2">
                  <c:v>0.25319375331913863</c:v>
                </c:pt>
                <c:pt idx="3">
                  <c:v>-2.6903948924802732</c:v>
                </c:pt>
                <c:pt idx="4">
                  <c:v>-3.6533691611769035</c:v>
                </c:pt>
                <c:pt idx="5">
                  <c:v>0.10435902952322484</c:v>
                </c:pt>
                <c:pt idx="6">
                  <c:v>-3.5595078490047145</c:v>
                </c:pt>
                <c:pt idx="7">
                  <c:v>-2.9605812620004892</c:v>
                </c:pt>
                <c:pt idx="8">
                  <c:v>-0.74910959408832878</c:v>
                </c:pt>
                <c:pt idx="9">
                  <c:v>-1.1990715322004883</c:v>
                </c:pt>
              </c:numCache>
            </c:numRef>
          </c:val>
        </c:ser>
        <c:ser>
          <c:idx val="2"/>
          <c:order val="2"/>
          <c:tx>
            <c:v>CDKN1B</c:v>
          </c:tx>
          <c:spPr>
            <a:solidFill>
              <a:srgbClr val="92D050"/>
            </a:solidFill>
            <a:ln>
              <a:solidFill>
                <a:sysClr val="windowText" lastClr="000000"/>
              </a:solidFill>
            </a:ln>
          </c:spPr>
          <c:invertIfNegative val="0"/>
          <c:val>
            <c:numRef>
              <c:f>STATS!$L$29:$L$38</c:f>
              <c:numCache>
                <c:formatCode>General</c:formatCode>
                <c:ptCount val="10"/>
                <c:pt idx="0">
                  <c:v>-1.2421477480918945</c:v>
                </c:pt>
                <c:pt idx="1">
                  <c:v>-0.26900708170672571</c:v>
                </c:pt>
                <c:pt idx="2">
                  <c:v>-1.5193838360078487</c:v>
                </c:pt>
                <c:pt idx="3">
                  <c:v>-0.11497101705088596</c:v>
                </c:pt>
                <c:pt idx="4">
                  <c:v>-2.7953579830822317</c:v>
                </c:pt>
                <c:pt idx="5">
                  <c:v>0.39153191384886743</c:v>
                </c:pt>
                <c:pt idx="6">
                  <c:v>0.29699179302518119</c:v>
                </c:pt>
                <c:pt idx="7">
                  <c:v>-0.45614836217738647</c:v>
                </c:pt>
                <c:pt idx="8">
                  <c:v>-0.3034198350595233</c:v>
                </c:pt>
                <c:pt idx="9">
                  <c:v>4.5979458757049785E-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280272256"/>
        <c:axId val="280196224"/>
      </c:barChart>
      <c:catAx>
        <c:axId val="280272256"/>
        <c:scaling>
          <c:orientation val="minMax"/>
        </c:scaling>
        <c:delete val="0"/>
        <c:axPos val="l"/>
        <c:majorGridlines>
          <c:spPr>
            <a:ln>
              <a:solidFill>
                <a:sysClr val="windowText" lastClr="000000"/>
              </a:solidFill>
            </a:ln>
          </c:spPr>
        </c:majorGridlines>
        <c:majorTickMark val="cross"/>
        <c:minorTickMark val="none"/>
        <c:tickLblPos val="low"/>
        <c:spPr>
          <a:ln>
            <a:solidFill>
              <a:sysClr val="windowText" lastClr="000000"/>
            </a:solidFill>
          </a:ln>
        </c:spPr>
        <c:crossAx val="280196224"/>
        <c:crosses val="autoZero"/>
        <c:auto val="1"/>
        <c:lblAlgn val="ctr"/>
        <c:lblOffset val="100"/>
        <c:noMultiLvlLbl val="0"/>
      </c:catAx>
      <c:valAx>
        <c:axId val="28019622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crossAx val="280272256"/>
        <c:crosses val="autoZero"/>
        <c:crossBetween val="between"/>
        <c:majorUnit val="1"/>
      </c:valAx>
      <c:spPr>
        <a:ln>
          <a:solidFill>
            <a:sysClr val="windowText" lastClr="000000"/>
          </a:solidFill>
        </a:ln>
      </c:spPr>
    </c:plotArea>
    <c:legend>
      <c:legendPos val="r"/>
      <c:layout>
        <c:manualLayout>
          <c:xMode val="edge"/>
          <c:yMode val="edge"/>
          <c:x val="0.81319575678040246"/>
          <c:y val="0.67091243802857981"/>
          <c:w val="0.14513757655293089"/>
          <c:h val="0.16743438320209975"/>
        </c:manualLayout>
      </c:layout>
      <c:overlay val="0"/>
      <c:spPr>
        <a:solidFill>
          <a:schemeClr val="bg1"/>
        </a:solidFill>
        <a:ln>
          <a:solidFill>
            <a:sysClr val="windowText" lastClr="000000"/>
          </a:solidFill>
        </a:ln>
      </c:spPr>
    </c:legend>
    <c:plotVisOnly val="1"/>
    <c:dispBlanksAs val="gap"/>
    <c:showDLblsOverMax val="0"/>
  </c:chart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57668482064741899"/>
          <c:y val="5.0925925925925923E-2"/>
          <c:w val="0.38552362204724411"/>
          <c:h val="0.80806794983960317"/>
        </c:manualLayout>
      </c:layout>
      <c:barChart>
        <c:barDir val="bar"/>
        <c:grouping val="clustered"/>
        <c:varyColors val="0"/>
        <c:ser>
          <c:idx val="0"/>
          <c:order val="0"/>
          <c:tx>
            <c:v>EGFR</c:v>
          </c:tx>
          <c:spPr>
            <a:solidFill>
              <a:srgbClr val="C00000"/>
            </a:solidFill>
            <a:ln>
              <a:solidFill>
                <a:sysClr val="windowText" lastClr="000000"/>
              </a:solidFill>
            </a:ln>
          </c:spPr>
          <c:invertIfNegative val="0"/>
          <c:cat>
            <c:strRef>
              <c:f>STATS!$B$29:$B$38</c:f>
              <c:strCache>
                <c:ptCount val="10"/>
                <c:pt idx="0">
                  <c:v>Uterine carcinosarcoma</c:v>
                </c:pt>
                <c:pt idx="1">
                  <c:v>Ovarian serous cystadenocarcinoma</c:v>
                </c:pt>
                <c:pt idx="2">
                  <c:v>Kidney renal papillary cell carcinoma</c:v>
                </c:pt>
                <c:pt idx="3">
                  <c:v>Cervical squamous cell carcinoma</c:v>
                </c:pt>
                <c:pt idx="4">
                  <c:v>Uterine corpus endometrial carcinoma</c:v>
                </c:pt>
                <c:pt idx="5">
                  <c:v>colon &amp; rectum adenocarcinoma</c:v>
                </c:pt>
                <c:pt idx="6">
                  <c:v>Head and Neck squamous cell carcinoma</c:v>
                </c:pt>
                <c:pt idx="7">
                  <c:v>Lung squamous cell carcinoma</c:v>
                </c:pt>
                <c:pt idx="8">
                  <c:v>Urothelial bladder carcinoma</c:v>
                </c:pt>
                <c:pt idx="9">
                  <c:v>Lung adenocarcinoma</c:v>
                </c:pt>
              </c:strCache>
            </c:strRef>
          </c:cat>
          <c:val>
            <c:numRef>
              <c:f>STATS!$G$29:$G$38</c:f>
              <c:numCache>
                <c:formatCode>General</c:formatCode>
                <c:ptCount val="10"/>
                <c:pt idx="0">
                  <c:v>3.2060332914613907</c:v>
                </c:pt>
                <c:pt idx="1">
                  <c:v>20.909900946630827</c:v>
                </c:pt>
                <c:pt idx="2">
                  <c:v>38.74184217414696</c:v>
                </c:pt>
                <c:pt idx="3">
                  <c:v>34.717568633063131</c:v>
                </c:pt>
                <c:pt idx="4">
                  <c:v>0.24636794064083936</c:v>
                </c:pt>
                <c:pt idx="5">
                  <c:v>62.107543267988845</c:v>
                </c:pt>
                <c:pt idx="6">
                  <c:v>170.39767423156096</c:v>
                </c:pt>
                <c:pt idx="7">
                  <c:v>153.47629289430213</c:v>
                </c:pt>
                <c:pt idx="8">
                  <c:v>39.522291118392353</c:v>
                </c:pt>
                <c:pt idx="9">
                  <c:v>106.98757905708348</c:v>
                </c:pt>
              </c:numCache>
            </c:numRef>
          </c:val>
        </c:ser>
        <c:ser>
          <c:idx val="1"/>
          <c:order val="1"/>
          <c:tx>
            <c:v>ERBB3</c:v>
          </c:tx>
          <c:spPr>
            <a:solidFill>
              <a:srgbClr val="0070C0"/>
            </a:solidFill>
            <a:ln>
              <a:solidFill>
                <a:sysClr val="windowText" lastClr="000000"/>
              </a:solidFill>
            </a:ln>
          </c:spPr>
          <c:invertIfNegative val="0"/>
          <c:cat>
            <c:strRef>
              <c:f>STATS!$B$29:$B$38</c:f>
              <c:strCache>
                <c:ptCount val="10"/>
                <c:pt idx="0">
                  <c:v>Uterine carcinosarcoma</c:v>
                </c:pt>
                <c:pt idx="1">
                  <c:v>Ovarian serous cystadenocarcinoma</c:v>
                </c:pt>
                <c:pt idx="2">
                  <c:v>Kidney renal papillary cell carcinoma</c:v>
                </c:pt>
                <c:pt idx="3">
                  <c:v>Cervical squamous cell carcinoma</c:v>
                </c:pt>
                <c:pt idx="4">
                  <c:v>Uterine corpus endometrial carcinoma</c:v>
                </c:pt>
                <c:pt idx="5">
                  <c:v>colon &amp; rectum adenocarcinoma</c:v>
                </c:pt>
                <c:pt idx="6">
                  <c:v>Head and Neck squamous cell carcinoma</c:v>
                </c:pt>
                <c:pt idx="7">
                  <c:v>Lung squamous cell carcinoma</c:v>
                </c:pt>
                <c:pt idx="8">
                  <c:v>Urothelial bladder carcinoma</c:v>
                </c:pt>
                <c:pt idx="9">
                  <c:v>Lung adenocarcinoma</c:v>
                </c:pt>
              </c:strCache>
            </c:strRef>
          </c:cat>
          <c:val>
            <c:numRef>
              <c:f>STATS!$K$29:$K$38</c:f>
              <c:numCache>
                <c:formatCode>General</c:formatCode>
                <c:ptCount val="10"/>
                <c:pt idx="0">
                  <c:v>-25.231603457359807</c:v>
                </c:pt>
                <c:pt idx="1">
                  <c:v>-54.988514824339084</c:v>
                </c:pt>
                <c:pt idx="2">
                  <c:v>-20.073913437879693</c:v>
                </c:pt>
                <c:pt idx="3">
                  <c:v>-49.906171785706206</c:v>
                </c:pt>
                <c:pt idx="4">
                  <c:v>-48.649065455418167</c:v>
                </c:pt>
                <c:pt idx="5">
                  <c:v>-0.11075188826147439</c:v>
                </c:pt>
                <c:pt idx="6">
                  <c:v>-168.45280252964511</c:v>
                </c:pt>
                <c:pt idx="7">
                  <c:v>-164.24385493415593</c:v>
                </c:pt>
                <c:pt idx="8">
                  <c:v>-44.993896512270112</c:v>
                </c:pt>
                <c:pt idx="9">
                  <c:v>-26.75695667166012</c:v>
                </c:pt>
              </c:numCache>
            </c:numRef>
          </c:val>
        </c:ser>
        <c:ser>
          <c:idx val="2"/>
          <c:order val="2"/>
          <c:tx>
            <c:v>CDKN1B</c:v>
          </c:tx>
          <c:spPr>
            <a:solidFill>
              <a:srgbClr val="92D050"/>
            </a:solidFill>
            <a:ln>
              <a:solidFill>
                <a:sysClr val="windowText" lastClr="000000"/>
              </a:solidFill>
            </a:ln>
          </c:spPr>
          <c:invertIfNegative val="0"/>
          <c:val>
            <c:numRef>
              <c:f>STATS!$M$29:$M$38</c:f>
              <c:numCache>
                <c:formatCode>General</c:formatCode>
                <c:ptCount val="10"/>
                <c:pt idx="0">
                  <c:v>-5.4209548724967478</c:v>
                </c:pt>
                <c:pt idx="1">
                  <c:v>-27.348606351386781</c:v>
                </c:pt>
                <c:pt idx="2">
                  <c:v>-49.125811227646295</c:v>
                </c:pt>
                <c:pt idx="3">
                  <c:v>-16.837808742751903</c:v>
                </c:pt>
                <c:pt idx="4">
                  <c:v>-25.044872808288126</c:v>
                </c:pt>
                <c:pt idx="5">
                  <c:v>-1.7449930879835196</c:v>
                </c:pt>
                <c:pt idx="6">
                  <c:v>-86.936756194930908</c:v>
                </c:pt>
                <c:pt idx="7">
                  <c:v>-43.77793507931937</c:v>
                </c:pt>
                <c:pt idx="8">
                  <c:v>-31.723276959339344</c:v>
                </c:pt>
                <c:pt idx="9">
                  <c:v>-32.59415407894626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280230528"/>
        <c:axId val="280953216"/>
      </c:barChart>
      <c:catAx>
        <c:axId val="280230528"/>
        <c:scaling>
          <c:orientation val="minMax"/>
        </c:scaling>
        <c:delete val="1"/>
        <c:axPos val="l"/>
        <c:majorGridlines>
          <c:spPr>
            <a:ln>
              <a:solidFill>
                <a:sysClr val="windowText" lastClr="000000"/>
              </a:solidFill>
            </a:ln>
          </c:spPr>
        </c:majorGridlines>
        <c:majorTickMark val="cross"/>
        <c:minorTickMark val="none"/>
        <c:tickLblPos val="low"/>
        <c:crossAx val="280953216"/>
        <c:crosses val="autoZero"/>
        <c:auto val="1"/>
        <c:lblAlgn val="ctr"/>
        <c:lblOffset val="100"/>
        <c:noMultiLvlLbl val="0"/>
      </c:catAx>
      <c:valAx>
        <c:axId val="280953216"/>
        <c:scaling>
          <c:orientation val="minMax"/>
          <c:max val="100"/>
          <c:min val="-100"/>
        </c:scaling>
        <c:delete val="0"/>
        <c:axPos val="b"/>
        <c:title>
          <c:tx>
            <c:rich>
              <a:bodyPr/>
              <a:lstStyle/>
              <a:p>
                <a:pPr>
                  <a:defRPr b="0"/>
                </a:pPr>
                <a:r>
                  <a:rPr lang="en-US" b="0" dirty="0" smtClean="0"/>
                  <a:t>-log10(</a:t>
                </a:r>
                <a:r>
                  <a:rPr lang="en-US" b="0" dirty="0" err="1" smtClean="0"/>
                  <a:t>Pval</a:t>
                </a:r>
                <a:r>
                  <a:rPr lang="en-US" b="0" dirty="0" smtClean="0"/>
                  <a:t>; Indication vs BRCA) × Sign(</a:t>
                </a:r>
                <a:r>
                  <a:rPr lang="el-GR" b="0" dirty="0" smtClean="0">
                    <a:latin typeface="Calibri"/>
                  </a:rPr>
                  <a:t>Δ</a:t>
                </a:r>
                <a:r>
                  <a:rPr lang="en-US" b="0" dirty="0" smtClean="0">
                    <a:latin typeface="Calibri"/>
                  </a:rPr>
                  <a:t>)</a:t>
                </a:r>
                <a:endParaRPr lang="en-US" b="0" dirty="0"/>
              </a:p>
            </c:rich>
          </c:tx>
          <c:layout>
            <c:manualLayout>
              <c:xMode val="edge"/>
              <c:yMode val="edge"/>
              <c:x val="0.28127777777777774"/>
              <c:y val="0.92960629921259841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crossAx val="280230528"/>
        <c:crosses val="autoZero"/>
        <c:crossBetween val="between"/>
        <c:majorUnit val="20"/>
      </c:valAx>
      <c:spPr>
        <a:ln>
          <a:solidFill>
            <a:sysClr val="windowText" lastClr="000000"/>
          </a:solidFill>
        </a:ln>
      </c:spPr>
    </c:plotArea>
    <c:legend>
      <c:legendPos val="r"/>
      <c:layout>
        <c:manualLayout>
          <c:xMode val="edge"/>
          <c:yMode val="edge"/>
          <c:x val="0.81319575678040246"/>
          <c:y val="0.67091243802857981"/>
          <c:w val="0.14513757655293089"/>
          <c:h val="0.16743438320209975"/>
        </c:manualLayout>
      </c:layout>
      <c:overlay val="0"/>
      <c:spPr>
        <a:solidFill>
          <a:schemeClr val="bg1"/>
        </a:solidFill>
        <a:ln>
          <a:solidFill>
            <a:sysClr val="windowText" lastClr="000000"/>
          </a:solidFill>
        </a:ln>
      </c:spPr>
    </c:legend>
    <c:plotVisOnly val="1"/>
    <c:dispBlanksAs val="gap"/>
    <c:showDLblsOverMax val="0"/>
  </c:chart>
  <c:externalData r:id="rId2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5A969B1C-6080-4F80-AD60-AF0D6D3C6D3E}" type="datetimeFigureOut">
              <a:rPr lang="en-US" smtClean="0"/>
              <a:t>3/10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97100" y="696913"/>
            <a:ext cx="2616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15790"/>
            <a:ext cx="5608320" cy="4183380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F4D1A1FA-BB6C-4C7B-B716-7471FC4FE1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008663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112B6E-CFBD-485C-8514-8C7EA2F79E63}" type="datetimeFigureOut">
              <a:rPr lang="en-US" smtClean="0"/>
              <a:t>3/1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B325F-DA5F-4F22-AE60-1C465EE09B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83667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112B6E-CFBD-485C-8514-8C7EA2F79E63}" type="datetimeFigureOut">
              <a:rPr lang="en-US" smtClean="0"/>
              <a:t>3/1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B325F-DA5F-4F22-AE60-1C465EE09B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04366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112B6E-CFBD-485C-8514-8C7EA2F79E63}" type="datetimeFigureOut">
              <a:rPr lang="en-US" smtClean="0"/>
              <a:t>3/1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B325F-DA5F-4F22-AE60-1C465EE09B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62209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112B6E-CFBD-485C-8514-8C7EA2F79E63}" type="datetimeFigureOut">
              <a:rPr lang="en-US" smtClean="0"/>
              <a:t>3/1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B325F-DA5F-4F22-AE60-1C465EE09B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00499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112B6E-CFBD-485C-8514-8C7EA2F79E63}" type="datetimeFigureOut">
              <a:rPr lang="en-US" smtClean="0"/>
              <a:t>3/1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B325F-DA5F-4F22-AE60-1C465EE09B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42632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112B6E-CFBD-485C-8514-8C7EA2F79E63}" type="datetimeFigureOut">
              <a:rPr lang="en-US" smtClean="0"/>
              <a:t>3/1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B325F-DA5F-4F22-AE60-1C465EE09B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19608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112B6E-CFBD-485C-8514-8C7EA2F79E63}" type="datetimeFigureOut">
              <a:rPr lang="en-US" smtClean="0"/>
              <a:t>3/10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B325F-DA5F-4F22-AE60-1C465EE09B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93816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112B6E-CFBD-485C-8514-8C7EA2F79E63}" type="datetimeFigureOut">
              <a:rPr lang="en-US" smtClean="0"/>
              <a:t>3/10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B325F-DA5F-4F22-AE60-1C465EE09B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00242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112B6E-CFBD-485C-8514-8C7EA2F79E63}" type="datetimeFigureOut">
              <a:rPr lang="en-US" smtClean="0"/>
              <a:t>3/10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B325F-DA5F-4F22-AE60-1C465EE09B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93445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112B6E-CFBD-485C-8514-8C7EA2F79E63}" type="datetimeFigureOut">
              <a:rPr lang="en-US" smtClean="0"/>
              <a:t>3/1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B325F-DA5F-4F22-AE60-1C465EE09B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47196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112B6E-CFBD-485C-8514-8C7EA2F79E63}" type="datetimeFigureOut">
              <a:rPr lang="en-US" smtClean="0"/>
              <a:t>3/1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B325F-DA5F-4F22-AE60-1C465EE09B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46309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112B6E-CFBD-485C-8514-8C7EA2F79E63}" type="datetimeFigureOut">
              <a:rPr lang="en-US" smtClean="0"/>
              <a:t>3/1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7B325F-DA5F-4F22-AE60-1C465EE09B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41629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9" name="Picture 5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938"/>
          <a:stretch/>
        </p:blipFill>
        <p:spPr bwMode="auto">
          <a:xfrm>
            <a:off x="533400" y="526942"/>
            <a:ext cx="5625074" cy="465465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pSp>
        <p:nvGrpSpPr>
          <p:cNvPr id="2" name="Group 1"/>
          <p:cNvGrpSpPr/>
          <p:nvPr/>
        </p:nvGrpSpPr>
        <p:grpSpPr>
          <a:xfrm>
            <a:off x="-122140" y="5622800"/>
            <a:ext cx="6553200" cy="2743200"/>
            <a:chOff x="-122140" y="5622800"/>
            <a:chExt cx="6553200" cy="2743200"/>
          </a:xfrm>
        </p:grpSpPr>
        <p:graphicFrame>
          <p:nvGraphicFramePr>
            <p:cNvPr id="10" name="Chart 9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235727074"/>
                </p:ext>
              </p:extLst>
            </p:nvPr>
          </p:nvGraphicFramePr>
          <p:xfrm>
            <a:off x="-122140" y="5622800"/>
            <a:ext cx="457200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11" name="Chart 10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350463031"/>
                </p:ext>
              </p:extLst>
            </p:nvPr>
          </p:nvGraphicFramePr>
          <p:xfrm>
            <a:off x="1859060" y="5622800"/>
            <a:ext cx="457200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</p:grpSp>
      <p:sp>
        <p:nvSpPr>
          <p:cNvPr id="6" name="TextBox 5"/>
          <p:cNvSpPr txBox="1"/>
          <p:nvPr/>
        </p:nvSpPr>
        <p:spPr>
          <a:xfrm>
            <a:off x="152400" y="434939"/>
            <a:ext cx="1066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A</a:t>
            </a:r>
            <a:endParaRPr lang="en-US" sz="1200" dirty="0"/>
          </a:p>
        </p:txBody>
      </p:sp>
      <p:sp>
        <p:nvSpPr>
          <p:cNvPr id="7" name="TextBox 6"/>
          <p:cNvSpPr txBox="1"/>
          <p:nvPr/>
        </p:nvSpPr>
        <p:spPr>
          <a:xfrm>
            <a:off x="152400" y="5590401"/>
            <a:ext cx="1066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B</a:t>
            </a:r>
            <a:endParaRPr lang="en-US" sz="1200" dirty="0"/>
          </a:p>
        </p:txBody>
      </p:sp>
      <p:sp>
        <p:nvSpPr>
          <p:cNvPr id="8" name="TextBox 7"/>
          <p:cNvSpPr txBox="1"/>
          <p:nvPr/>
        </p:nvSpPr>
        <p:spPr>
          <a:xfrm>
            <a:off x="0" y="0"/>
            <a:ext cx="1066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smtClean="0"/>
              <a:t>S10 Figure</a:t>
            </a:r>
            <a:endParaRPr lang="en-US" sz="1200" dirty="0"/>
          </a:p>
        </p:txBody>
      </p:sp>
      <p:sp>
        <p:nvSpPr>
          <p:cNvPr id="3" name="TextBox 2"/>
          <p:cNvSpPr txBox="1"/>
          <p:nvPr/>
        </p:nvSpPr>
        <p:spPr>
          <a:xfrm>
            <a:off x="2660137" y="5540692"/>
            <a:ext cx="1447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/>
              <a:t>HER2+</a:t>
            </a:r>
            <a:endParaRPr lang="en-US" sz="1000" dirty="0"/>
          </a:p>
        </p:txBody>
      </p:sp>
      <p:sp>
        <p:nvSpPr>
          <p:cNvPr id="12" name="TextBox 11"/>
          <p:cNvSpPr txBox="1"/>
          <p:nvPr/>
        </p:nvSpPr>
        <p:spPr>
          <a:xfrm>
            <a:off x="4648200" y="5544979"/>
            <a:ext cx="1447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/>
              <a:t>HER2-</a:t>
            </a:r>
            <a:endParaRPr lang="en-US" sz="1000" dirty="0"/>
          </a:p>
        </p:txBody>
      </p:sp>
    </p:spTree>
    <p:extLst>
      <p:ext uri="{BB962C8B-B14F-4D97-AF65-F5344CB8AC3E}">
        <p14:creationId xmlns:p14="http://schemas.microsoft.com/office/powerpoint/2010/main" val="403679868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11040</TotalTime>
  <Words>18</Words>
  <Application>Microsoft Office PowerPoint</Application>
  <PresentationFormat>On-screen Show (4:3)</PresentationFormat>
  <Paragraphs>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Merrimack Pharmaceuticals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niel Kirouac</dc:creator>
  <cp:lastModifiedBy>Jinyan Du</cp:lastModifiedBy>
  <cp:revision>393</cp:revision>
  <cp:lastPrinted>2014-06-20T13:57:28Z</cp:lastPrinted>
  <dcterms:created xsi:type="dcterms:W3CDTF">2013-12-19T16:18:28Z</dcterms:created>
  <dcterms:modified xsi:type="dcterms:W3CDTF">2016-03-10T23:16:15Z</dcterms:modified>
</cp:coreProperties>
</file>